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DB7E2D-1C72-464C-B83C-1CA0116AFF8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0932AA-F198-476C-A59C-986DA6DEE8D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9FBFD2-92C5-4A83-A78D-617B4C9DB12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73960E-2F29-4247-9E70-03DD19E8194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3AF053-FC44-4B68-BEAB-000CD96E310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0F36AF-D213-4419-8747-5CE01794E5C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39C085-E028-428D-B1EF-EC471DD3583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3C1312-08EB-490C-874B-75BB5C4A771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E5DFDD-506F-4497-ACAC-DA88A7DD68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EAD432-0539-4AC2-9D36-43C42243B0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D50083-36B5-4BE8-8120-F9F331540F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88E76F-C263-4650-AEAB-132466D8B9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BED1057-71D9-4A23-84A3-96256F16F9E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"/>
          <p:cNvSpPr/>
          <p:nvPr/>
        </p:nvSpPr>
        <p:spPr>
          <a:xfrm>
            <a:off x="304920" y="609480"/>
            <a:ext cx="8991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Calibri"/>
              </a:rPr>
              <a:t>Table S1. Functional gene grouping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Straight Connector 3"/>
          <p:cNvSpPr/>
          <p:nvPr/>
        </p:nvSpPr>
        <p:spPr>
          <a:xfrm>
            <a:off x="380880" y="914400"/>
            <a:ext cx="8305920" cy="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Straight Connector 5"/>
          <p:cNvSpPr/>
          <p:nvPr/>
        </p:nvSpPr>
        <p:spPr>
          <a:xfrm>
            <a:off x="304920" y="5791320"/>
            <a:ext cx="8305560" cy="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6"/>
          <p:cNvSpPr/>
          <p:nvPr/>
        </p:nvSpPr>
        <p:spPr>
          <a:xfrm>
            <a:off x="380880" y="990720"/>
            <a:ext cx="8305920" cy="4839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POPTOSI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 ABL, BRCA1, CIDIA, GADD45</a:t>
            </a:r>
            <a:r>
              <a:rPr b="0" lang="el-G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α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GADD45</a:t>
            </a:r>
            <a:r>
              <a:rPr b="0" lang="el-G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γ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GML, IP6K3,  PCBP4, AIFM1 (PDCD8), PPP1R15A, RAD21, p53, p73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ELL CYCLE ARREST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CHK1, CHK2, DDIT3 (CHOP), GADD45</a:t>
            </a:r>
            <a:r>
              <a:rPr b="0" lang="el-G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α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GML, GTSE1, HUS1, MAP2K6, MAPK12, PCBP4, PPP1R15A, RAD17, RAD9A, SESN1, ZAK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ELL CYCLE CHECK POINT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ATR, BRCA1, FANCG, NBN (NBS1), RAD1, RBBBP8, SMC1A(SMC1L1), p53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AMAGED DNA BINDING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ANKRD17, BRCA1, DDB1, DMC1, ERCC1, FANCG, FEN1, MPG, MSH2, MSH3, N4BP2, NBN (NBS1), OGG1, PMS2P3 (PMS2L9), PNKP, RAD1, RAD18, RAD51, RAD51B, REV1 (REV1L). SEMA4A, XPA, XPC, XRCC1, XRCC2, XRCC3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UCLEOTIDE-EXCISION REPAIR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DDB1, ERCC1, ERCC2 (XPD), LIG1, NTHL1, OGG1, PCNA, PNKP, RPA1,  p53, XPA, XPC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ASE-EXCISION REPAIR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, MUTYH, NTHL1, OGG1, UNG. APEX1, MBD4, MP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SMATCH REPAIR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ABL1, ANKRD17, EXO1, MLH1, MLH3, MSH2, MSH3, MUTYH, N4BP2, PMS1, PMS2, PMS2P3 (PMS2L9), p73, TREX1</a:t>
            </a:r>
            <a:br>
              <a:rPr sz="1200"/>
            </a:b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OUBLE STRAND BREAK REPAIR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CIB1, FEN1, XRCC6 (G22P1), XRCC6BP1 (KUB3), MRE11A, MNN(NBS1), PRKDC, RAD21, RAD50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THER GENES RELATED TO DNA REPAIR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ATM, ATRX, BTG2, CCNH, CDK7, CRY1, ERCC2 (XPD), GTF2H1, GTF2H2, IGHMBP2, LIG1, MNAT1, PCNA, RPA1, SUMO1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6-17T18:27:24Z</dcterms:created>
  <dc:creator>Yong, Kwon Joong (NIH/NCI) [E]</dc:creator>
  <dc:description/>
  <dc:language>en-US</dc:language>
  <cp:lastModifiedBy>Yong, Kwon Joong (NIH/NCI) [E]</cp:lastModifiedBy>
  <dcterms:modified xsi:type="dcterms:W3CDTF">2014-09-04T14:58:55Z</dcterms:modified>
  <cp:revision>3</cp:revision>
  <dc:subject/>
  <dc:title>PowerPoint Presentation</dc:title>
</cp:coreProperties>
</file>